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3212369"/>
              </p:ext>
            </p:extLst>
          </p:nvPr>
        </p:nvGraphicFramePr>
        <p:xfrm>
          <a:off x="1905002" y="3047999"/>
          <a:ext cx="5289549" cy="1588612"/>
        </p:xfrm>
        <a:graphic>
          <a:graphicData uri="http://schemas.openxmlformats.org/drawingml/2006/table">
            <a:tbl>
              <a:tblPr/>
              <a:tblGrid>
                <a:gridCol w="84326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4104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4104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4104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4104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4104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741048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322166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Ig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Ma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6332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Ctr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7.0140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0.220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5.600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6332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si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3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81923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8.600000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7.520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04800" y="838200"/>
            <a:ext cx="1132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A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35268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5064483"/>
              </p:ext>
            </p:extLst>
          </p:nvPr>
        </p:nvGraphicFramePr>
        <p:xfrm>
          <a:off x="761999" y="2971800"/>
          <a:ext cx="6477002" cy="1752600"/>
        </p:xfrm>
        <a:graphic>
          <a:graphicData uri="http://schemas.openxmlformats.org/drawingml/2006/table">
            <a:tbl>
              <a:tblPr/>
              <a:tblGrid>
                <a:gridCol w="92528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2528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2528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2528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2528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2528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2528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441960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inpu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H3k27a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41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3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9.6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6.0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68.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8686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3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02.5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86.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13.4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2400" y="609600"/>
            <a:ext cx="1010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J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0593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6179346"/>
              </p:ext>
            </p:extLst>
          </p:nvPr>
        </p:nvGraphicFramePr>
        <p:xfrm>
          <a:off x="2438400" y="2971800"/>
          <a:ext cx="4184651" cy="2049622"/>
        </p:xfrm>
        <a:graphic>
          <a:graphicData uri="http://schemas.openxmlformats.org/drawingml/2006/table">
            <a:tbl>
              <a:tblPr/>
              <a:tblGrid>
                <a:gridCol w="85161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7185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7185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18932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8080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Contro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-lncEGFL7OS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-lncEGFL7OS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-lncEGFL7OS2/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138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3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6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138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6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138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9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2400" y="457200"/>
            <a:ext cx="1056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28386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2400" y="762000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L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3535200"/>
              </p:ext>
            </p:extLst>
          </p:nvPr>
        </p:nvGraphicFramePr>
        <p:xfrm>
          <a:off x="2133600" y="2362199"/>
          <a:ext cx="4260850" cy="1897222"/>
        </p:xfrm>
        <a:graphic>
          <a:graphicData uri="http://schemas.openxmlformats.org/drawingml/2006/table">
            <a:tbl>
              <a:tblPr/>
              <a:tblGrid>
                <a:gridCol w="86712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9137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9137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21097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7479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err="1">
                          <a:effectLst/>
                          <a:latin typeface="Arial"/>
                        </a:rPr>
                        <a:t>siControl</a:t>
                      </a:r>
                      <a:endParaRPr lang="en-US" sz="12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si-lncEGFL7OS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si-lncEGFL7OS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si-lncEGFL7OS2/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830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9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7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8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9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830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8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2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8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830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9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0.9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2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0.5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569954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0643562"/>
              </p:ext>
            </p:extLst>
          </p:nvPr>
        </p:nvGraphicFramePr>
        <p:xfrm>
          <a:off x="1600197" y="2590799"/>
          <a:ext cx="5607052" cy="1588612"/>
        </p:xfrm>
        <a:graphic>
          <a:graphicData uri="http://schemas.openxmlformats.org/drawingml/2006/table">
            <a:tbl>
              <a:tblPr/>
              <a:tblGrid>
                <a:gridCol w="89387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8552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8552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85529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85529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8552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78552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401938"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Ig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H3K27a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019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siCtr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1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8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67.1818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70.241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72.3314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7847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si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9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.3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0.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8.45614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5.1000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20.32116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04800" y="457200"/>
            <a:ext cx="1124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B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67550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5242420"/>
              </p:ext>
            </p:extLst>
          </p:nvPr>
        </p:nvGraphicFramePr>
        <p:xfrm>
          <a:off x="3460750" y="3543139"/>
          <a:ext cx="2711451" cy="1714660"/>
        </p:xfrm>
        <a:graphic>
          <a:graphicData uri="http://schemas.openxmlformats.org/drawingml/2006/table">
            <a:tbl>
              <a:tblPr/>
              <a:tblGrid>
                <a:gridCol w="9038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0381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0381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4286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Ctr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-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Max-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286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2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1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286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286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4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1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2400" y="838200"/>
            <a:ext cx="1122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C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73522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3400" y="762000"/>
            <a:ext cx="11418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D: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3446901"/>
              </p:ext>
            </p:extLst>
          </p:nvPr>
        </p:nvGraphicFramePr>
        <p:xfrm>
          <a:off x="2971800" y="2743200"/>
          <a:ext cx="3168651" cy="2552860"/>
        </p:xfrm>
        <a:graphic>
          <a:graphicData uri="http://schemas.openxmlformats.org/drawingml/2006/table">
            <a:tbl>
              <a:tblPr/>
              <a:tblGrid>
                <a:gridCol w="10562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5621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5621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6382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siCtr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siMax-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siMax-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6382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0.7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0.1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6382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1.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0.2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0.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6382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effectLst/>
                          <a:latin typeface="Arial"/>
                        </a:rPr>
                        <a:t>0.1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effectLst/>
                          <a:latin typeface="Arial"/>
                        </a:rPr>
                        <a:t>0.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861530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4963363"/>
              </p:ext>
            </p:extLst>
          </p:nvPr>
        </p:nvGraphicFramePr>
        <p:xfrm>
          <a:off x="3352800" y="2133600"/>
          <a:ext cx="3200400" cy="3200399"/>
        </p:xfrm>
        <a:graphic>
          <a:graphicData uri="http://schemas.openxmlformats.org/drawingml/2006/table">
            <a:tbl>
              <a:tblPr/>
              <a:tblGrid>
                <a:gridCol w="141697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78342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15815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Ad-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Ad-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396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.9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5.5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396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5.7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396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6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4.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04800" y="914400"/>
            <a:ext cx="1111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E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52022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5785734"/>
              </p:ext>
            </p:extLst>
          </p:nvPr>
        </p:nvGraphicFramePr>
        <p:xfrm>
          <a:off x="3124200" y="2362200"/>
          <a:ext cx="2813050" cy="3090071"/>
        </p:xfrm>
        <a:graphic>
          <a:graphicData uri="http://schemas.openxmlformats.org/drawingml/2006/table">
            <a:tbl>
              <a:tblPr/>
              <a:tblGrid>
                <a:gridCol w="124547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56757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101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Ad-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Ad-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191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.3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191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3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.0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191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.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5191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2.3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8600" y="914400"/>
            <a:ext cx="1104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F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07146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8765146"/>
              </p:ext>
            </p:extLst>
          </p:nvPr>
        </p:nvGraphicFramePr>
        <p:xfrm>
          <a:off x="1143000" y="2209800"/>
          <a:ext cx="6476995" cy="2438400"/>
        </p:xfrm>
        <a:graphic>
          <a:graphicData uri="http://schemas.openxmlformats.org/drawingml/2006/table">
            <a:tbl>
              <a:tblPr/>
              <a:tblGrid>
                <a:gridCol w="92528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2528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2528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2528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2528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2528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2528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614901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inpu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Ma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6149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Ad-</a:t>
                      </a:r>
                      <a:r>
                        <a:rPr lang="en-US" sz="1400" b="1" i="0" u="none" strike="noStrike" dirty="0" err="1" smtClean="0">
                          <a:effectLst/>
                          <a:latin typeface="Arial"/>
                        </a:rPr>
                        <a:t>gfp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1.01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6.6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0.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57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2085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Ad-lncEGFL7OS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1.12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.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93.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72.0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00.4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8600" y="1066800"/>
            <a:ext cx="1082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66814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5109747"/>
              </p:ext>
            </p:extLst>
          </p:nvPr>
        </p:nvGraphicFramePr>
        <p:xfrm>
          <a:off x="1524000" y="2514600"/>
          <a:ext cx="5638801" cy="1664811"/>
        </p:xfrm>
        <a:graphic>
          <a:graphicData uri="http://schemas.openxmlformats.org/drawingml/2006/table">
            <a:tbl>
              <a:tblPr/>
              <a:tblGrid>
                <a:gridCol w="80554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0554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0554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80554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0554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0554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80554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421217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inpu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Ma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212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4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5.1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0.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6.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8223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6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8.2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57.5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75.4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04800" y="685800"/>
            <a:ext cx="1080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414015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0416093"/>
              </p:ext>
            </p:extLst>
          </p:nvPr>
        </p:nvGraphicFramePr>
        <p:xfrm>
          <a:off x="990600" y="3200400"/>
          <a:ext cx="6172201" cy="1222851"/>
        </p:xfrm>
        <a:graphic>
          <a:graphicData uri="http://schemas.openxmlformats.org/drawingml/2006/table">
            <a:tbl>
              <a:tblPr/>
              <a:tblGrid>
                <a:gridCol w="88174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308371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inpu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H3K27ac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083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7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64.5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78.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01.4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6061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5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32.0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50.9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321.2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52400" y="838200"/>
            <a:ext cx="994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57118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36</Words>
  <Application>Microsoft Macintosh PowerPoint</Application>
  <PresentationFormat>On-screen Show (4:3)</PresentationFormat>
  <Paragraphs>182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7</cp:revision>
  <dcterms:created xsi:type="dcterms:W3CDTF">2018-12-03T10:45:52Z</dcterms:created>
  <dcterms:modified xsi:type="dcterms:W3CDTF">2018-12-03T10:55:26Z</dcterms:modified>
</cp:coreProperties>
</file>